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80" d="100"/>
          <a:sy n="80" d="100"/>
        </p:scale>
        <p:origin x="66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897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796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900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287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422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2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2480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2/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50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2/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293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2/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326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2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186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2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5541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749B1D-8CAE-4A83-972E-931BDC5EB2FB}" type="datetimeFigureOut">
              <a:rPr lang="en-US" smtClean="0"/>
              <a:t>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9679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18DA01-3C97-46DE-8B26-EEFE491FAD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200" dirty="0"/>
              <a:t>For the following boxplots, white boxes are prosimians and grey boxes are platyrrhines. Ins=insectivore, </a:t>
            </a:r>
            <a:r>
              <a:rPr lang="en-US" sz="2200" dirty="0" err="1"/>
              <a:t>fol</a:t>
            </a:r>
            <a:r>
              <a:rPr lang="en-US" sz="2200" dirty="0"/>
              <a:t>=folivore, </a:t>
            </a:r>
            <a:r>
              <a:rPr lang="en-US" sz="2200" dirty="0" err="1"/>
              <a:t>omn</a:t>
            </a:r>
            <a:r>
              <a:rPr lang="en-US" sz="2200" dirty="0"/>
              <a:t>=omnivore, </a:t>
            </a:r>
            <a:r>
              <a:rPr lang="en-US" sz="2200" dirty="0" err="1"/>
              <a:t>frug</a:t>
            </a:r>
            <a:r>
              <a:rPr lang="en-US" sz="2200" dirty="0"/>
              <a:t>=frugivore, and </a:t>
            </a:r>
            <a:r>
              <a:rPr lang="en-US" sz="2200" dirty="0" err="1"/>
              <a:t>hof</a:t>
            </a:r>
            <a:r>
              <a:rPr lang="en-US" sz="2200" dirty="0"/>
              <a:t>=hard object feeder. Boxplots of topographic metrics presented in the following order: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FDF977-F630-4927-B5B3-A1AB839ECB13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Triangle count </a:t>
            </a:r>
          </a:p>
          <a:p>
            <a:pPr lvl="1"/>
            <a:r>
              <a:rPr lang="en-US" dirty="0"/>
              <a:t>Smoothed, EEC</a:t>
            </a:r>
          </a:p>
          <a:p>
            <a:pPr lvl="1"/>
            <a:r>
              <a:rPr lang="en-US" dirty="0"/>
              <a:t>Smoothed, BCO</a:t>
            </a:r>
          </a:p>
          <a:p>
            <a:pPr lvl="1"/>
            <a:r>
              <a:rPr lang="en-US" dirty="0"/>
              <a:t>Unsmoothed, EEC</a:t>
            </a:r>
          </a:p>
          <a:p>
            <a:pPr lvl="1"/>
            <a:r>
              <a:rPr lang="en-US" dirty="0"/>
              <a:t>Unsmoothed, BCO</a:t>
            </a:r>
          </a:p>
          <a:p>
            <a:r>
              <a:rPr lang="en-US" dirty="0"/>
              <a:t>Resolution</a:t>
            </a:r>
          </a:p>
          <a:p>
            <a:pPr lvl="1"/>
            <a:r>
              <a:rPr lang="en-US" dirty="0"/>
              <a:t>Smoothed, EEC</a:t>
            </a:r>
          </a:p>
          <a:p>
            <a:pPr lvl="1"/>
            <a:r>
              <a:rPr lang="en-US" dirty="0"/>
              <a:t>Smoothed, BCO</a:t>
            </a:r>
          </a:p>
          <a:p>
            <a:pPr lvl="1"/>
            <a:r>
              <a:rPr lang="en-US" dirty="0"/>
              <a:t>Unsmoothed, EEC</a:t>
            </a:r>
          </a:p>
          <a:p>
            <a:pPr lvl="1"/>
            <a:r>
              <a:rPr lang="en-US" dirty="0"/>
              <a:t>Unsmoothed, BCO</a:t>
            </a:r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93067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Triangle count, smoothed, EEC</a:t>
            </a:r>
          </a:p>
        </p:txBody>
      </p:sp>
      <p:pic>
        <p:nvPicPr>
          <p:cNvPr id="6" name="Content Placeholder 5">
            <a:extLst>
              <a:ext uri="{FF2B5EF4-FFF2-40B4-BE49-F238E27FC236}">
                <a16:creationId xmlns:a16="http://schemas.microsoft.com/office/drawing/2014/main" id="{26A8EC00-9131-4093-A5B6-B50C902C5CB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88" y="2821781"/>
            <a:ext cx="5915025" cy="5915025"/>
          </a:xfrm>
        </p:spPr>
      </p:pic>
    </p:spTree>
    <p:extLst>
      <p:ext uri="{BB962C8B-B14F-4D97-AF65-F5344CB8AC3E}">
        <p14:creationId xmlns:p14="http://schemas.microsoft.com/office/powerpoint/2010/main" val="15440611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Triangle count, smoothed, BCO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E241741C-41A9-4B34-B86E-0258FE9748B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88" y="2821781"/>
            <a:ext cx="5915025" cy="5915025"/>
          </a:xfrm>
        </p:spPr>
      </p:pic>
    </p:spTree>
    <p:extLst>
      <p:ext uri="{BB962C8B-B14F-4D97-AF65-F5344CB8AC3E}">
        <p14:creationId xmlns:p14="http://schemas.microsoft.com/office/powerpoint/2010/main" val="17804102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Triangle count, unsmoothed, EEC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58E49D07-2F1C-474B-BBB6-8201EC8DD27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88" y="2821781"/>
            <a:ext cx="5915025" cy="5915025"/>
          </a:xfrm>
        </p:spPr>
      </p:pic>
    </p:spTree>
    <p:extLst>
      <p:ext uri="{BB962C8B-B14F-4D97-AF65-F5344CB8AC3E}">
        <p14:creationId xmlns:p14="http://schemas.microsoft.com/office/powerpoint/2010/main" val="16868475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Triangle count, unsmoothed, BCO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8D0FDDA2-1333-441C-BDB6-9DAEB0D3BFE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88" y="2821781"/>
            <a:ext cx="5915025" cy="5915025"/>
          </a:xfrm>
        </p:spPr>
      </p:pic>
    </p:spTree>
    <p:extLst>
      <p:ext uri="{BB962C8B-B14F-4D97-AF65-F5344CB8AC3E}">
        <p14:creationId xmlns:p14="http://schemas.microsoft.com/office/powerpoint/2010/main" val="15381380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Resolution, smoothed, EEC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2BBC233B-BC46-4BD5-8B58-7E47AC54C3E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88" y="2821781"/>
            <a:ext cx="5915025" cy="5915025"/>
          </a:xfrm>
        </p:spPr>
      </p:pic>
    </p:spTree>
    <p:extLst>
      <p:ext uri="{BB962C8B-B14F-4D97-AF65-F5344CB8AC3E}">
        <p14:creationId xmlns:p14="http://schemas.microsoft.com/office/powerpoint/2010/main" val="11579291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Resolution, smoothed, BCO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2C51F39B-BAEB-492F-8104-061DCBF47B7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88" y="2821781"/>
            <a:ext cx="5915025" cy="5915025"/>
          </a:xfrm>
        </p:spPr>
      </p:pic>
    </p:spTree>
    <p:extLst>
      <p:ext uri="{BB962C8B-B14F-4D97-AF65-F5344CB8AC3E}">
        <p14:creationId xmlns:p14="http://schemas.microsoft.com/office/powerpoint/2010/main" val="16694737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Resolution, unsmoothed, EEC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CFAB448E-EA75-4625-B73C-1C816F5084D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88" y="2821781"/>
            <a:ext cx="5915025" cy="5915025"/>
          </a:xfrm>
        </p:spPr>
      </p:pic>
    </p:spTree>
    <p:extLst>
      <p:ext uri="{BB962C8B-B14F-4D97-AF65-F5344CB8AC3E}">
        <p14:creationId xmlns:p14="http://schemas.microsoft.com/office/powerpoint/2010/main" val="32099821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Resolution, unsmoothed, BCO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7D4D37F2-68B9-4336-A87C-E01483F89C4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88" y="2821781"/>
            <a:ext cx="5915025" cy="5915025"/>
          </a:xfrm>
        </p:spPr>
      </p:pic>
    </p:spTree>
    <p:extLst>
      <p:ext uri="{BB962C8B-B14F-4D97-AF65-F5344CB8AC3E}">
        <p14:creationId xmlns:p14="http://schemas.microsoft.com/office/powerpoint/2010/main" val="28311376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</TotalTime>
  <Words>119</Words>
  <Application>Microsoft Office PowerPoint</Application>
  <PresentationFormat>A4 Paper (210x297 mm)</PresentationFormat>
  <Paragraphs>1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For the following boxplots, white boxes are prosimians and grey boxes are platyrrhines. Ins=insectivore, fol=folivore, omn=omnivore, frug=frugivore, and hof=hard object feeder. Boxplots of topographic metrics presented in the following order:</vt:lpstr>
      <vt:lpstr>Triangle count, smoothed, EEC</vt:lpstr>
      <vt:lpstr>Triangle count, smoothed, BCO</vt:lpstr>
      <vt:lpstr>Triangle count, unsmoothed, EEC</vt:lpstr>
      <vt:lpstr>Triangle count, unsmoothed, BCO</vt:lpstr>
      <vt:lpstr>Resolution, smoothed, EEC</vt:lpstr>
      <vt:lpstr>Resolution, smoothed, BCO</vt:lpstr>
      <vt:lpstr>Resolution, unsmoothed, EEC</vt:lpstr>
      <vt:lpstr>Resolution, unsmoothed, BCO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Berthaume</dc:creator>
  <cp:lastModifiedBy>Berthaume, Michael</cp:lastModifiedBy>
  <cp:revision>12</cp:revision>
  <dcterms:created xsi:type="dcterms:W3CDTF">2018-01-19T20:31:50Z</dcterms:created>
  <dcterms:modified xsi:type="dcterms:W3CDTF">2018-02-07T16:22:43Z</dcterms:modified>
</cp:coreProperties>
</file>